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57" r:id="rId2"/>
    <p:sldId id="258" r:id="rId3"/>
    <p:sldId id="259" r:id="rId4"/>
    <p:sldId id="260" r:id="rId5"/>
    <p:sldId id="261" r:id="rId6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69" d="100"/>
          <a:sy n="69" d="100"/>
        </p:scale>
        <p:origin x="-1723" y="-8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1.xlsx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2.xlsx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User\AppData\Local\Microsoft\Windows\Temporary%20Internet%20Files\Content.Outlook\4D0KPU4B\Mcl1_promoter_Luciferase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v>Mcl-1 mRNA</c:v>
          </c:tx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SKBr3!$B$58:$F$58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.10280285242072651</c:v>
                  </c:pt>
                  <c:pt idx="2">
                    <c:v>9.5366973613750655E-2</c:v>
                  </c:pt>
                  <c:pt idx="3">
                    <c:v>0.49067633191534848</c:v>
                  </c:pt>
                  <c:pt idx="4">
                    <c:v>0.1901703958671172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KBr3!$B$38:$F$38</c:f>
              <c:strCache>
                <c:ptCount val="5"/>
                <c:pt idx="0">
                  <c:v>CNT</c:v>
                </c:pt>
                <c:pt idx="1">
                  <c:v>veh</c:v>
                </c:pt>
                <c:pt idx="2">
                  <c:v>1 hour</c:v>
                </c:pt>
                <c:pt idx="3">
                  <c:v>2 hour</c:v>
                </c:pt>
                <c:pt idx="4">
                  <c:v>6 hour</c:v>
                </c:pt>
              </c:strCache>
            </c:strRef>
          </c:cat>
          <c:val>
            <c:numRef>
              <c:f>SKBr3!$B$57:$F$57</c:f>
              <c:numCache>
                <c:formatCode>General</c:formatCode>
                <c:ptCount val="5"/>
                <c:pt idx="0">
                  <c:v>1</c:v>
                </c:pt>
                <c:pt idx="1">
                  <c:v>1.3069761938006152</c:v>
                </c:pt>
                <c:pt idx="2">
                  <c:v>1.4835765250211324</c:v>
                </c:pt>
                <c:pt idx="3">
                  <c:v>1.1117953152141526</c:v>
                </c:pt>
                <c:pt idx="4">
                  <c:v>0.8010711676232711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62367232"/>
        <c:axId val="62368768"/>
      </c:barChart>
      <c:catAx>
        <c:axId val="62367232"/>
        <c:scaling>
          <c:orientation val="minMax"/>
        </c:scaling>
        <c:delete val="0"/>
        <c:axPos val="b"/>
        <c:majorTickMark val="out"/>
        <c:minorTickMark val="none"/>
        <c:tickLblPos val="nextTo"/>
        <c:crossAx val="62368768"/>
        <c:crosses val="autoZero"/>
        <c:auto val="1"/>
        <c:lblAlgn val="ctr"/>
        <c:lblOffset val="100"/>
        <c:noMultiLvlLbl val="0"/>
      </c:catAx>
      <c:valAx>
        <c:axId val="62368768"/>
        <c:scaling>
          <c:orientation val="minMax"/>
          <c:max val="6"/>
        </c:scaling>
        <c:delete val="0"/>
        <c:axPos val="l"/>
        <c:numFmt formatCode="General" sourceLinked="1"/>
        <c:majorTickMark val="out"/>
        <c:minorTickMark val="none"/>
        <c:tickLblPos val="nextTo"/>
        <c:crossAx val="62367232"/>
        <c:crosses val="autoZero"/>
        <c:crossBetween val="between"/>
      </c:valAx>
    </c:plotArea>
    <c:plotVisOnly val="1"/>
    <c:dispBlanksAs val="gap"/>
    <c:showDLblsOverMax val="0"/>
  </c:chart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v>Mcl-1 mRNA</c:v>
          </c:tx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'231 cells'!$C$58:$F$58</c:f>
                <c:numCache>
                  <c:formatCode>General</c:formatCode>
                  <c:ptCount val="4"/>
                  <c:pt idx="0">
                    <c:v>4.884797341412573E-2</c:v>
                  </c:pt>
                  <c:pt idx="1">
                    <c:v>4.1192007702529843E-2</c:v>
                  </c:pt>
                  <c:pt idx="2">
                    <c:v>4.3313157636886875E-2</c:v>
                  </c:pt>
                  <c:pt idx="3">
                    <c:v>5.3157831518690468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231 cells'!$B$38:$F$38</c:f>
              <c:strCache>
                <c:ptCount val="5"/>
                <c:pt idx="0">
                  <c:v>CNT</c:v>
                </c:pt>
                <c:pt idx="1">
                  <c:v>veh</c:v>
                </c:pt>
                <c:pt idx="2">
                  <c:v>1 hour</c:v>
                </c:pt>
                <c:pt idx="3">
                  <c:v>2 hour</c:v>
                </c:pt>
                <c:pt idx="4">
                  <c:v>6 hour</c:v>
                </c:pt>
              </c:strCache>
            </c:strRef>
          </c:cat>
          <c:val>
            <c:numRef>
              <c:f>'231 cells'!$B$57:$F$57</c:f>
              <c:numCache>
                <c:formatCode>General</c:formatCode>
                <c:ptCount val="5"/>
                <c:pt idx="0">
                  <c:v>1</c:v>
                </c:pt>
                <c:pt idx="1">
                  <c:v>1.0897075744712466</c:v>
                </c:pt>
                <c:pt idx="2">
                  <c:v>1.048717210852486</c:v>
                </c:pt>
                <c:pt idx="3">
                  <c:v>1.0352941590409916</c:v>
                </c:pt>
                <c:pt idx="4">
                  <c:v>1.036782870767935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65313408"/>
        <c:axId val="65352064"/>
      </c:barChart>
      <c:catAx>
        <c:axId val="65313408"/>
        <c:scaling>
          <c:orientation val="minMax"/>
        </c:scaling>
        <c:delete val="0"/>
        <c:axPos val="b"/>
        <c:majorTickMark val="out"/>
        <c:minorTickMark val="none"/>
        <c:tickLblPos val="nextTo"/>
        <c:crossAx val="65352064"/>
        <c:crosses val="autoZero"/>
        <c:auto val="1"/>
        <c:lblAlgn val="ctr"/>
        <c:lblOffset val="100"/>
        <c:noMultiLvlLbl val="0"/>
      </c:catAx>
      <c:valAx>
        <c:axId val="65352064"/>
        <c:scaling>
          <c:orientation val="minMax"/>
          <c:max val="6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crossAx val="65313408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[Mcl1_promoter_Luciferase.xls]Sheet1!$C$58:$C$59</c:f>
                <c:numCache>
                  <c:formatCode>General</c:formatCode>
                  <c:ptCount val="2"/>
                  <c:pt idx="0">
                    <c:v>0.1</c:v>
                  </c:pt>
                  <c:pt idx="1">
                    <c:v>0.1400000000000000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[Mcl1_promoter_Luciferase.xls]Sheet1!$A$58:$A$59</c:f>
              <c:strCache>
                <c:ptCount val="2"/>
                <c:pt idx="0">
                  <c:v>ETOH</c:v>
                </c:pt>
                <c:pt idx="1">
                  <c:v>Estrogen</c:v>
                </c:pt>
              </c:strCache>
            </c:strRef>
          </c:cat>
          <c:val>
            <c:numRef>
              <c:f>[Mcl1_promoter_Luciferase.xls]Sheet1!$B$58:$B$59</c:f>
              <c:numCache>
                <c:formatCode>General</c:formatCode>
                <c:ptCount val="2"/>
                <c:pt idx="0">
                  <c:v>1</c:v>
                </c:pt>
                <c:pt idx="1">
                  <c:v>1.5913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59781504"/>
        <c:axId val="59783040"/>
      </c:barChart>
      <c:catAx>
        <c:axId val="59781504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1600"/>
            </a:pPr>
            <a:endParaRPr lang="en-US"/>
          </a:p>
        </c:txPr>
        <c:crossAx val="59783040"/>
        <c:crosses val="autoZero"/>
        <c:auto val="1"/>
        <c:lblAlgn val="ctr"/>
        <c:lblOffset val="100"/>
        <c:noMultiLvlLbl val="0"/>
      </c:catAx>
      <c:valAx>
        <c:axId val="5978304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59781504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5F6A27C-5998-4ED6-BFD7-282384555C9B}" type="datetimeFigureOut">
              <a:rPr lang="en-US" smtClean="0"/>
              <a:t>6/2/201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4ABE391-9773-4286-91B0-361C21AF58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485570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mtClean="0"/>
              <a:t>Figure 12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C74013C-951B-2948-A6C7-4CC85A2F9EBF}" type="slidenum">
              <a:rPr lang="en-US" smtClean="0"/>
              <a:t>5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1911684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EE9A6E-6F16-41EA-81B3-254733F6C7A6}" type="datetimeFigureOut">
              <a:rPr lang="en-US" smtClean="0"/>
              <a:t>6/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2AD1F6-D7A9-4EA3-8830-30F84AECF4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58240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EE9A6E-6F16-41EA-81B3-254733F6C7A6}" type="datetimeFigureOut">
              <a:rPr lang="en-US" smtClean="0"/>
              <a:t>6/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2AD1F6-D7A9-4EA3-8830-30F84AECF4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49693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EE9A6E-6F16-41EA-81B3-254733F6C7A6}" type="datetimeFigureOut">
              <a:rPr lang="en-US" smtClean="0"/>
              <a:t>6/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2AD1F6-D7A9-4EA3-8830-30F84AECF4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73988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EE9A6E-6F16-41EA-81B3-254733F6C7A6}" type="datetimeFigureOut">
              <a:rPr lang="en-US" smtClean="0"/>
              <a:t>6/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2AD1F6-D7A9-4EA3-8830-30F84AECF4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00147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EE9A6E-6F16-41EA-81B3-254733F6C7A6}" type="datetimeFigureOut">
              <a:rPr lang="en-US" smtClean="0"/>
              <a:t>6/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2AD1F6-D7A9-4EA3-8830-30F84AECF4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01553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EE9A6E-6F16-41EA-81B3-254733F6C7A6}" type="datetimeFigureOut">
              <a:rPr lang="en-US" smtClean="0"/>
              <a:t>6/2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2AD1F6-D7A9-4EA3-8830-30F84AECF4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30355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EE9A6E-6F16-41EA-81B3-254733F6C7A6}" type="datetimeFigureOut">
              <a:rPr lang="en-US" smtClean="0"/>
              <a:t>6/2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2AD1F6-D7A9-4EA3-8830-30F84AECF4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35067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EE9A6E-6F16-41EA-81B3-254733F6C7A6}" type="datetimeFigureOut">
              <a:rPr lang="en-US" smtClean="0"/>
              <a:t>6/2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2AD1F6-D7A9-4EA3-8830-30F84AECF4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08264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EE9A6E-6F16-41EA-81B3-254733F6C7A6}" type="datetimeFigureOut">
              <a:rPr lang="en-US" smtClean="0"/>
              <a:t>6/2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2AD1F6-D7A9-4EA3-8830-30F84AECF4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86844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EE9A6E-6F16-41EA-81B3-254733F6C7A6}" type="datetimeFigureOut">
              <a:rPr lang="en-US" smtClean="0"/>
              <a:t>6/2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2AD1F6-D7A9-4EA3-8830-30F84AECF4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64859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EE9A6E-6F16-41EA-81B3-254733F6C7A6}" type="datetimeFigureOut">
              <a:rPr lang="en-US" smtClean="0"/>
              <a:t>6/2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2AD1F6-D7A9-4EA3-8830-30F84AECF4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66305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EE9A6E-6F16-41EA-81B3-254733F6C7A6}" type="datetimeFigureOut">
              <a:rPr lang="en-US" smtClean="0"/>
              <a:t>6/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2AD1F6-D7A9-4EA3-8830-30F84AECF4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76280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jpeg"/><Relationship Id="rId5" Type="http://schemas.openxmlformats.org/officeDocument/2006/relationships/image" Target="../media/image3.jpe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microsoft.com/office/2007/relationships/hdphoto" Target="../media/hdphoto2.wdp"/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4"/>
          <p:cNvSpPr txBox="1"/>
          <p:nvPr/>
        </p:nvSpPr>
        <p:spPr>
          <a:xfrm>
            <a:off x="6798364" y="3562194"/>
            <a:ext cx="18636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 smtClean="0"/>
              <a:t>Mcl</a:t>
            </a:r>
            <a:r>
              <a:rPr lang="en-US" dirty="0"/>
              <a:t>-</a:t>
            </a:r>
            <a:r>
              <a:rPr lang="en-US" dirty="0" smtClean="0"/>
              <a:t>1</a:t>
            </a:r>
            <a:endParaRPr lang="en-US" dirty="0"/>
          </a:p>
        </p:txBody>
      </p:sp>
      <p:sp>
        <p:nvSpPr>
          <p:cNvPr id="10" name="TextBox 5"/>
          <p:cNvSpPr txBox="1"/>
          <p:nvPr/>
        </p:nvSpPr>
        <p:spPr>
          <a:xfrm>
            <a:off x="6798364" y="3867652"/>
            <a:ext cx="18636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/>
              <a:t>A</a:t>
            </a:r>
            <a:r>
              <a:rPr lang="en-US" dirty="0" smtClean="0"/>
              <a:t>ctin</a:t>
            </a:r>
            <a:endParaRPr lang="en-US" dirty="0"/>
          </a:p>
        </p:txBody>
      </p:sp>
      <p:sp>
        <p:nvSpPr>
          <p:cNvPr id="11" name="TextBox 6"/>
          <p:cNvSpPr txBox="1"/>
          <p:nvPr/>
        </p:nvSpPr>
        <p:spPr>
          <a:xfrm>
            <a:off x="6798366" y="2630860"/>
            <a:ext cx="151785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 smtClean="0"/>
              <a:t>Progesterone receptor</a:t>
            </a:r>
            <a:endParaRPr lang="en-US" dirty="0"/>
          </a:p>
        </p:txBody>
      </p:sp>
      <p:pic>
        <p:nvPicPr>
          <p:cNvPr id="12" name="Picture 11" descr="mcl1 and actin_june 6 2012-1.jpg"/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aturation sat="0"/>
                    </a14:imgEffect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4144" t="28959" r="57050" b="9348"/>
          <a:stretch/>
        </p:blipFill>
        <p:spPr>
          <a:xfrm>
            <a:off x="4921586" y="2317399"/>
            <a:ext cx="1876778" cy="1919585"/>
          </a:xfrm>
          <a:prstGeom prst="rect">
            <a:avLst/>
          </a:prstGeom>
        </p:spPr>
      </p:pic>
      <p:sp>
        <p:nvSpPr>
          <p:cNvPr id="13" name="TextBox 9"/>
          <p:cNvSpPr txBox="1"/>
          <p:nvPr/>
        </p:nvSpPr>
        <p:spPr>
          <a:xfrm>
            <a:off x="4288751" y="3481801"/>
            <a:ext cx="2035621" cy="6771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dirty="0" smtClean="0"/>
              <a:t>-55 kda</a:t>
            </a:r>
          </a:p>
          <a:p>
            <a:endParaRPr lang="en-US" sz="1200" dirty="0"/>
          </a:p>
          <a:p>
            <a:endParaRPr lang="en-US" sz="1400" dirty="0"/>
          </a:p>
        </p:txBody>
      </p:sp>
      <p:sp>
        <p:nvSpPr>
          <p:cNvPr id="14" name="TextBox 10"/>
          <p:cNvSpPr txBox="1"/>
          <p:nvPr/>
        </p:nvSpPr>
        <p:spPr>
          <a:xfrm>
            <a:off x="4274320" y="2578790"/>
            <a:ext cx="2035621" cy="10464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dirty="0" smtClean="0"/>
              <a:t>-100 kda</a:t>
            </a:r>
          </a:p>
          <a:p>
            <a:endParaRPr lang="en-US" sz="1200" dirty="0" smtClean="0"/>
          </a:p>
          <a:p>
            <a:endParaRPr lang="en-US" sz="1200" dirty="0"/>
          </a:p>
          <a:p>
            <a:r>
              <a:rPr lang="en-US" sz="1200" dirty="0" smtClean="0"/>
              <a:t>-70 kda</a:t>
            </a:r>
          </a:p>
          <a:p>
            <a:endParaRPr lang="en-US" sz="1400" dirty="0"/>
          </a:p>
        </p:txBody>
      </p:sp>
      <p:sp>
        <p:nvSpPr>
          <p:cNvPr id="15" name="TextBox 11"/>
          <p:cNvSpPr txBox="1"/>
          <p:nvPr/>
        </p:nvSpPr>
        <p:spPr>
          <a:xfrm>
            <a:off x="4274320" y="2217072"/>
            <a:ext cx="2035621" cy="6771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en-US" sz="1200" dirty="0"/>
          </a:p>
          <a:p>
            <a:r>
              <a:rPr lang="en-US" sz="1200" dirty="0" smtClean="0"/>
              <a:t>-130 kda</a:t>
            </a:r>
          </a:p>
          <a:p>
            <a:endParaRPr lang="en-US" sz="1400" dirty="0"/>
          </a:p>
        </p:txBody>
      </p:sp>
      <p:sp>
        <p:nvSpPr>
          <p:cNvPr id="16" name="Rectangle 15"/>
          <p:cNvSpPr/>
          <p:nvPr/>
        </p:nvSpPr>
        <p:spPr>
          <a:xfrm>
            <a:off x="4921586" y="2317399"/>
            <a:ext cx="1876778" cy="1244795"/>
          </a:xfrm>
          <a:prstGeom prst="rect">
            <a:avLst/>
          </a:prstGeom>
          <a:noFill/>
          <a:ln w="3175" cmpd="sng">
            <a:solidFill>
              <a:srgbClr val="00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  <p:sp>
        <p:nvSpPr>
          <p:cNvPr id="17" name="Rectangle 16"/>
          <p:cNvSpPr/>
          <p:nvPr/>
        </p:nvSpPr>
        <p:spPr>
          <a:xfrm>
            <a:off x="4921586" y="3562194"/>
            <a:ext cx="1876778" cy="305458"/>
          </a:xfrm>
          <a:prstGeom prst="rect">
            <a:avLst/>
          </a:prstGeom>
          <a:noFill/>
          <a:ln w="3175" cmpd="sng">
            <a:solidFill>
              <a:srgbClr val="00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  <p:sp>
        <p:nvSpPr>
          <p:cNvPr id="18" name="Rectangle 17"/>
          <p:cNvSpPr/>
          <p:nvPr/>
        </p:nvSpPr>
        <p:spPr>
          <a:xfrm>
            <a:off x="4921586" y="3867653"/>
            <a:ext cx="1876778" cy="369332"/>
          </a:xfrm>
          <a:prstGeom prst="rect">
            <a:avLst/>
          </a:prstGeom>
          <a:noFill/>
          <a:ln w="3175" cmpd="sng">
            <a:solidFill>
              <a:srgbClr val="00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  <p:pic>
        <p:nvPicPr>
          <p:cNvPr id="19" name="table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921587" y="1946559"/>
            <a:ext cx="1876779" cy="370840"/>
          </a:xfrm>
          <a:prstGeom prst="rect">
            <a:avLst/>
          </a:prstGeom>
        </p:spPr>
      </p:pic>
      <p:sp>
        <p:nvSpPr>
          <p:cNvPr id="20" name="TextBox 8"/>
          <p:cNvSpPr txBox="1"/>
          <p:nvPr/>
        </p:nvSpPr>
        <p:spPr>
          <a:xfrm>
            <a:off x="5246142" y="4304623"/>
            <a:ext cx="18767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 smtClean="0"/>
              <a:t>MCF-7</a:t>
            </a:r>
            <a:endParaRPr lang="en-US" dirty="0"/>
          </a:p>
        </p:txBody>
      </p:sp>
      <p:sp>
        <p:nvSpPr>
          <p:cNvPr id="21" name="TextBox 24"/>
          <p:cNvSpPr txBox="1"/>
          <p:nvPr/>
        </p:nvSpPr>
        <p:spPr>
          <a:xfrm>
            <a:off x="4296841" y="3966091"/>
            <a:ext cx="2035621" cy="6771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dirty="0" smtClean="0"/>
              <a:t>-35 kda</a:t>
            </a:r>
          </a:p>
          <a:p>
            <a:endParaRPr lang="en-US" sz="1200" dirty="0"/>
          </a:p>
          <a:p>
            <a:endParaRPr lang="en-US" sz="1400" dirty="0"/>
          </a:p>
        </p:txBody>
      </p:sp>
      <p:sp>
        <p:nvSpPr>
          <p:cNvPr id="22" name="TextBox 21"/>
          <p:cNvSpPr txBox="1"/>
          <p:nvPr/>
        </p:nvSpPr>
        <p:spPr>
          <a:xfrm>
            <a:off x="1094049" y="1164657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S1</a:t>
            </a:r>
            <a:endParaRPr lang="en-US" dirty="0"/>
          </a:p>
        </p:txBody>
      </p:sp>
      <p:pic>
        <p:nvPicPr>
          <p:cNvPr id="23" name="Picture 2" descr="\\SBG-LAB1\SBG-Lab1-My Documents\Liz\Western Blots\140509_Breastcancerlines_1min.jpg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341" t="52699" r="62591" b="44767"/>
          <a:stretch/>
        </p:blipFill>
        <p:spPr bwMode="auto">
          <a:xfrm>
            <a:off x="1022878" y="2672208"/>
            <a:ext cx="1440873" cy="24938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4" name="Picture 4" descr="\\SBG-LAB1\SBG-Lab1-My Documents\Liz\Western Blots\140509_Breastcancerlines_10sec.jpg"/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667" t="22507" r="65265" b="73833"/>
          <a:stretch/>
        </p:blipFill>
        <p:spPr bwMode="auto">
          <a:xfrm>
            <a:off x="1022878" y="2988078"/>
            <a:ext cx="1440873" cy="36021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6" name="Picture 6" descr="\\SBG-LAB1\SBG-Lab1-My Documents\Liz\Western Blots\140509_Breastcancerlines_1min.jpg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5749" t="15280" r="25181" b="82092"/>
          <a:stretch/>
        </p:blipFill>
        <p:spPr bwMode="auto">
          <a:xfrm>
            <a:off x="1022878" y="2308813"/>
            <a:ext cx="1440873" cy="25861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7" name="TextBox 26"/>
          <p:cNvSpPr txBox="1"/>
          <p:nvPr/>
        </p:nvSpPr>
        <p:spPr>
          <a:xfrm>
            <a:off x="2500697" y="2308813"/>
            <a:ext cx="16192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ogesterone Receptor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2500697" y="2658399"/>
            <a:ext cx="13300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strogen Receptor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2638010" y="3010300"/>
            <a:ext cx="5277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ctin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 rot="16200000">
            <a:off x="1015078" y="1921626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231</a:t>
            </a:r>
            <a:endParaRPr lang="en-US" sz="1200" dirty="0"/>
          </a:p>
        </p:txBody>
      </p:sp>
      <p:sp>
        <p:nvSpPr>
          <p:cNvPr id="32" name="TextBox 31"/>
          <p:cNvSpPr txBox="1"/>
          <p:nvPr/>
        </p:nvSpPr>
        <p:spPr>
          <a:xfrm rot="16200000">
            <a:off x="1282574" y="1910373"/>
            <a:ext cx="5501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SKBr3</a:t>
            </a:r>
            <a:endParaRPr lang="en-US" sz="1200" dirty="0"/>
          </a:p>
        </p:txBody>
      </p:sp>
      <p:sp>
        <p:nvSpPr>
          <p:cNvPr id="33" name="TextBox 32"/>
          <p:cNvSpPr txBox="1"/>
          <p:nvPr/>
        </p:nvSpPr>
        <p:spPr>
          <a:xfrm rot="16200000">
            <a:off x="1594502" y="1916802"/>
            <a:ext cx="5533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Mcf-7</a:t>
            </a:r>
            <a:endParaRPr lang="en-US" sz="1200" dirty="0"/>
          </a:p>
        </p:txBody>
      </p:sp>
      <p:sp>
        <p:nvSpPr>
          <p:cNvPr id="34" name="TextBox 33"/>
          <p:cNvSpPr txBox="1"/>
          <p:nvPr/>
        </p:nvSpPr>
        <p:spPr>
          <a:xfrm rot="16200000">
            <a:off x="1972255" y="1909761"/>
            <a:ext cx="49725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ZR75</a:t>
            </a:r>
            <a:endParaRPr lang="en-US" sz="1200" dirty="0"/>
          </a:p>
        </p:txBody>
      </p:sp>
      <p:sp>
        <p:nvSpPr>
          <p:cNvPr id="2" name="TextBox 1"/>
          <p:cNvSpPr txBox="1"/>
          <p:nvPr/>
        </p:nvSpPr>
        <p:spPr>
          <a:xfrm>
            <a:off x="529389" y="1849971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35" name="TextBox 34"/>
          <p:cNvSpPr txBox="1"/>
          <p:nvPr/>
        </p:nvSpPr>
        <p:spPr>
          <a:xfrm>
            <a:off x="3956604" y="1900948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062087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91997434"/>
              </p:ext>
            </p:extLst>
          </p:nvPr>
        </p:nvGraphicFramePr>
        <p:xfrm>
          <a:off x="4914900" y="1143000"/>
          <a:ext cx="4000500" cy="28067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Chart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05485040"/>
              </p:ext>
            </p:extLst>
          </p:nvPr>
        </p:nvGraphicFramePr>
        <p:xfrm>
          <a:off x="596900" y="1244600"/>
          <a:ext cx="4013200" cy="2667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1168400" y="4165600"/>
            <a:ext cx="19125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MDA-MB 231 cells</a:t>
            </a:r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6325134" y="4050097"/>
            <a:ext cx="11945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KBr3 cells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 rot="16200000">
            <a:off x="-394635" y="2152985"/>
            <a:ext cx="14176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old increase</a:t>
            </a:r>
            <a:endParaRPr lang="en-US" dirty="0"/>
          </a:p>
        </p:txBody>
      </p:sp>
      <p:sp>
        <p:nvSpPr>
          <p:cNvPr id="11" name="TextBox 10"/>
          <p:cNvSpPr txBox="1"/>
          <p:nvPr/>
        </p:nvSpPr>
        <p:spPr>
          <a:xfrm rot="16200000">
            <a:off x="4021418" y="2152985"/>
            <a:ext cx="14176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old increase</a:t>
            </a:r>
            <a:endParaRPr 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1112271" y="381000"/>
            <a:ext cx="10953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 </a:t>
            </a:r>
            <a:r>
              <a:rPr lang="en-US" dirty="0" smtClean="0"/>
              <a:t>Figure </a:t>
            </a:r>
            <a:r>
              <a:rPr lang="en-US" dirty="0" smtClean="0"/>
              <a:t>S2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1163787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 rot="16200000">
            <a:off x="1792638" y="2485201"/>
            <a:ext cx="3175356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1000" b="1" i="0" u="none" strike="noStrike" kern="1200" baseline="0">
                <a:solidFill>
                  <a:srgbClr val="000000"/>
                </a:solidFill>
                <a:latin typeface="Verdana"/>
                <a:ea typeface="Verdana"/>
                <a:cs typeface="Verdana"/>
              </a:defRPr>
            </a:pPr>
            <a:r>
              <a:rPr lang="en-US" sz="1600" dirty="0">
                <a:latin typeface="Times New Roman" pitchFamily="18" charset="0"/>
                <a:cs typeface="Times New Roman" pitchFamily="18" charset="0"/>
              </a:rPr>
              <a:t>Fold increase in luciferase activity</a:t>
            </a:r>
          </a:p>
        </p:txBody>
      </p:sp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35777255"/>
              </p:ext>
            </p:extLst>
          </p:nvPr>
        </p:nvGraphicFramePr>
        <p:xfrm>
          <a:off x="3733800" y="391338"/>
          <a:ext cx="3581400" cy="46253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8" name="TextBox 7"/>
          <p:cNvSpPr txBox="1"/>
          <p:nvPr/>
        </p:nvSpPr>
        <p:spPr>
          <a:xfrm>
            <a:off x="457200" y="471657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S3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9373677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Content Placeholder 3"/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5282" t="20731" r="34053" b="58978"/>
          <a:stretch/>
        </p:blipFill>
        <p:spPr>
          <a:xfrm>
            <a:off x="3862940" y="1219200"/>
            <a:ext cx="2865121" cy="850393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286978" y="2099192"/>
            <a:ext cx="2575962" cy="24929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spcAft>
                <a:spcPts val="600"/>
              </a:spcAft>
            </a:pPr>
            <a:r>
              <a:rPr lang="en-US" dirty="0" smtClean="0"/>
              <a:t>Input </a:t>
            </a:r>
          </a:p>
          <a:p>
            <a:pPr algn="r">
              <a:spcAft>
                <a:spcPts val="600"/>
              </a:spcAft>
            </a:pPr>
            <a:r>
              <a:rPr lang="en-US" dirty="0" smtClean="0"/>
              <a:t>positive control for </a:t>
            </a:r>
            <a:r>
              <a:rPr lang="en-US" dirty="0" err="1" smtClean="0"/>
              <a:t>ChIP</a:t>
            </a:r>
            <a:r>
              <a:rPr lang="en-US" dirty="0" smtClean="0"/>
              <a:t> </a:t>
            </a:r>
          </a:p>
          <a:p>
            <a:pPr algn="r">
              <a:spcAft>
                <a:spcPts val="600"/>
              </a:spcAft>
            </a:pPr>
            <a:r>
              <a:rPr lang="en-US" dirty="0" smtClean="0"/>
              <a:t>Negative control for </a:t>
            </a:r>
            <a:r>
              <a:rPr lang="en-US" dirty="0" err="1" smtClean="0"/>
              <a:t>ChIP</a:t>
            </a:r>
            <a:r>
              <a:rPr lang="en-US" dirty="0" smtClean="0"/>
              <a:t> </a:t>
            </a:r>
          </a:p>
          <a:p>
            <a:pPr algn="r">
              <a:spcAft>
                <a:spcPts val="600"/>
              </a:spcAft>
            </a:pPr>
            <a:r>
              <a:rPr lang="en-US" dirty="0" smtClean="0"/>
              <a:t>No treatment</a:t>
            </a:r>
          </a:p>
          <a:p>
            <a:pPr algn="r">
              <a:spcAft>
                <a:spcPts val="600"/>
              </a:spcAft>
            </a:pPr>
            <a:r>
              <a:rPr lang="en-US" dirty="0" smtClean="0"/>
              <a:t>E2 treatment, 6 hours</a:t>
            </a:r>
          </a:p>
          <a:p>
            <a:pPr algn="r">
              <a:spcAft>
                <a:spcPts val="600"/>
              </a:spcAft>
            </a:pPr>
            <a:r>
              <a:rPr lang="en-US" dirty="0" smtClean="0"/>
              <a:t>No template control</a:t>
            </a:r>
          </a:p>
          <a:p>
            <a:pPr algn="r">
              <a:spcAft>
                <a:spcPts val="600"/>
              </a:spcAft>
            </a:pPr>
            <a:endParaRPr lang="en-US" dirty="0"/>
          </a:p>
        </p:txBody>
      </p:sp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89763387"/>
              </p:ext>
            </p:extLst>
          </p:nvPr>
        </p:nvGraphicFramePr>
        <p:xfrm>
          <a:off x="3862940" y="2099192"/>
          <a:ext cx="2865121" cy="2096268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409303"/>
                <a:gridCol w="409303"/>
                <a:gridCol w="409303"/>
                <a:gridCol w="409303"/>
                <a:gridCol w="409303"/>
                <a:gridCol w="409303"/>
                <a:gridCol w="409303"/>
              </a:tblGrid>
              <a:tr h="349378"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+</a:t>
                      </a:r>
                      <a:endParaRPr lang="en-US" dirty="0"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-</a:t>
                      </a:r>
                      <a:endParaRPr lang="en-US" dirty="0"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-</a:t>
                      </a:r>
                      <a:endParaRPr lang="en-US" dirty="0"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-</a:t>
                      </a:r>
                      <a:endParaRPr lang="en-US" dirty="0"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-</a:t>
                      </a:r>
                      <a:endParaRPr lang="en-US" dirty="0"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+</a:t>
                      </a:r>
                      <a:endParaRPr lang="en-US" dirty="0"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-</a:t>
                      </a:r>
                      <a:endParaRPr lang="en-US" dirty="0"/>
                    </a:p>
                  </a:txBody>
                  <a:tcPr marL="0" marR="0" marT="0" marB="0"/>
                </a:tc>
              </a:tr>
              <a:tr h="349378"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-</a:t>
                      </a:r>
                      <a:endParaRPr lang="en-US" dirty="0"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+</a:t>
                      </a:r>
                      <a:endParaRPr lang="en-US" dirty="0"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-</a:t>
                      </a:r>
                      <a:endParaRPr lang="en-US" dirty="0"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-</a:t>
                      </a:r>
                      <a:endParaRPr lang="en-US" dirty="0"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-</a:t>
                      </a:r>
                      <a:endParaRPr lang="en-US" dirty="0"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-</a:t>
                      </a:r>
                      <a:endParaRPr lang="en-US" dirty="0"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-</a:t>
                      </a:r>
                      <a:endParaRPr lang="en-US" dirty="0"/>
                    </a:p>
                  </a:txBody>
                  <a:tcPr marL="0" marR="0" marT="0" marB="0"/>
                </a:tc>
              </a:tr>
              <a:tr h="349378"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-</a:t>
                      </a:r>
                      <a:endParaRPr lang="en-US" dirty="0"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-</a:t>
                      </a:r>
                      <a:endParaRPr lang="en-US" dirty="0"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+</a:t>
                      </a:r>
                      <a:endParaRPr lang="en-US" dirty="0"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-</a:t>
                      </a:r>
                      <a:endParaRPr lang="en-US" dirty="0"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-</a:t>
                      </a:r>
                      <a:endParaRPr lang="en-US" dirty="0"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-</a:t>
                      </a:r>
                      <a:endParaRPr lang="en-US" dirty="0"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-</a:t>
                      </a:r>
                      <a:endParaRPr lang="en-US" dirty="0"/>
                    </a:p>
                  </a:txBody>
                  <a:tcPr marL="0" marR="0" marT="0" marB="0"/>
                </a:tc>
              </a:tr>
              <a:tr h="349378"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-</a:t>
                      </a:r>
                      <a:endParaRPr lang="en-US" dirty="0"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-</a:t>
                      </a:r>
                      <a:endParaRPr lang="en-US" dirty="0"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-</a:t>
                      </a:r>
                      <a:endParaRPr lang="en-US" dirty="0"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+</a:t>
                      </a:r>
                      <a:endParaRPr lang="en-US" dirty="0"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-</a:t>
                      </a:r>
                      <a:endParaRPr lang="en-US" dirty="0"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-</a:t>
                      </a:r>
                      <a:endParaRPr lang="en-US" dirty="0"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-</a:t>
                      </a:r>
                      <a:endParaRPr lang="en-US" dirty="0"/>
                    </a:p>
                  </a:txBody>
                  <a:tcPr marL="0" marR="0" marT="0" marB="0"/>
                </a:tc>
              </a:tr>
              <a:tr h="349378"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-</a:t>
                      </a:r>
                      <a:endParaRPr lang="en-US" dirty="0"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-</a:t>
                      </a:r>
                      <a:endParaRPr lang="en-US" dirty="0"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-</a:t>
                      </a:r>
                      <a:endParaRPr lang="en-US" dirty="0"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-</a:t>
                      </a:r>
                      <a:endParaRPr lang="en-US" dirty="0"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+</a:t>
                      </a:r>
                      <a:endParaRPr lang="en-US" dirty="0"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-</a:t>
                      </a:r>
                      <a:endParaRPr lang="en-US" dirty="0"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-</a:t>
                      </a:r>
                      <a:endParaRPr lang="en-US" dirty="0"/>
                    </a:p>
                  </a:txBody>
                  <a:tcPr marL="0" marR="0" marT="0" marB="0"/>
                </a:tc>
              </a:tr>
              <a:tr h="349378"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-</a:t>
                      </a:r>
                      <a:endParaRPr lang="en-US" dirty="0"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-</a:t>
                      </a:r>
                      <a:endParaRPr lang="en-US" dirty="0"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-</a:t>
                      </a:r>
                      <a:endParaRPr lang="en-US" dirty="0"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-</a:t>
                      </a:r>
                      <a:endParaRPr lang="en-US" dirty="0"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-</a:t>
                      </a:r>
                      <a:endParaRPr lang="en-US" dirty="0"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-</a:t>
                      </a:r>
                      <a:endParaRPr lang="en-US" dirty="0"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+</a:t>
                      </a:r>
                      <a:endParaRPr lang="en-US" dirty="0"/>
                    </a:p>
                  </a:txBody>
                  <a:tcPr marL="0" marR="0" marT="0" marB="0"/>
                </a:tc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1094049" y="471657"/>
            <a:ext cx="23920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l Figure </a:t>
            </a:r>
            <a:r>
              <a:rPr lang="en-US" dirty="0" smtClean="0"/>
              <a:t>S4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2033814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endParaRPr lang="en-US" dirty="0" smtClean="0"/>
          </a:p>
          <a:p>
            <a:pPr marL="457200" lvl="1" indent="0">
              <a:buNone/>
            </a:pPr>
            <a:endParaRPr lang="en-US" b="1" dirty="0" smtClean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1F31F6-9ABD-DC4D-AB8E-212EDAD6B82E}" type="slidenum">
              <a:rPr lang="en-US" smtClean="0"/>
              <a:t>5</a:t>
            </a:fld>
            <a:endParaRPr lang="en-US"/>
          </a:p>
        </p:txBody>
      </p:sp>
      <p:pic>
        <p:nvPicPr>
          <p:cNvPr id="5" name="Picture 4"/>
          <p:cNvPicPr/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94049" y="1752600"/>
            <a:ext cx="6660422" cy="2444497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1094049" y="1164657"/>
            <a:ext cx="23920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l Figure </a:t>
            </a:r>
            <a:r>
              <a:rPr lang="en-US" dirty="0" smtClean="0"/>
              <a:t>S5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383719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68</TotalTime>
  <Words>123</Words>
  <Application>Microsoft Office PowerPoint</Application>
  <PresentationFormat>On-screen Show (4:3)</PresentationFormat>
  <Paragraphs>83</Paragraphs>
  <Slides>5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6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ser</dc:creator>
  <cp:lastModifiedBy>User</cp:lastModifiedBy>
  <cp:revision>4</cp:revision>
  <dcterms:created xsi:type="dcterms:W3CDTF">2014-05-25T03:44:13Z</dcterms:created>
  <dcterms:modified xsi:type="dcterms:W3CDTF">2014-06-03T00:26:35Z</dcterms:modified>
</cp:coreProperties>
</file>